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스케치, 흑백, 눈, 모노크롬이(가) 표시된 사진&#10;&#10;자동 생성된 설명">
            <a:extLst>
              <a:ext uri="{FF2B5EF4-FFF2-40B4-BE49-F238E27FC236}">
                <a16:creationId xmlns:a16="http://schemas.microsoft.com/office/drawing/2014/main" id="{382EF499-1FF7-BB85-0862-7156534ACB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53" t="26961" r="19341" b="45588"/>
          <a:stretch/>
        </p:blipFill>
        <p:spPr>
          <a:xfrm>
            <a:off x="3891159" y="1511356"/>
            <a:ext cx="6284662" cy="3254598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0" y="2785631"/>
            <a:ext cx="266930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ERK 1/2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2669309" y="3079970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553527" y="4549777"/>
            <a:ext cx="138545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189A82AB-AD7B-C9CD-3F1B-BE25BC9F62C1}"/>
              </a:ext>
            </a:extLst>
          </p:cNvPr>
          <p:cNvCxnSpPr>
            <a:cxnSpLocks/>
          </p:cNvCxnSpPr>
          <p:nvPr/>
        </p:nvCxnSpPr>
        <p:spPr>
          <a:xfrm>
            <a:off x="6098310" y="4565899"/>
            <a:ext cx="149572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4243885" y="4533657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5850490" y="4565898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4470400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4823690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5215192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5488245" y="2320006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p-ERK 1/2 expression in total thymocytes from mice</a:t>
            </a:r>
          </a:p>
          <a:p>
            <a:r>
              <a:rPr lang="en-US" altLang="ko-KR" dirty="0"/>
              <a:t>(Fig 4C) </a:t>
            </a:r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89199E-91C3-59A8-DF9A-865DEBAD72A1}"/>
              </a:ext>
            </a:extLst>
          </p:cNvPr>
          <p:cNvSpPr txBox="1"/>
          <p:nvPr/>
        </p:nvSpPr>
        <p:spPr>
          <a:xfrm>
            <a:off x="6041629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046A37-295C-CF3F-0F2E-A97A3F8F7EE4}"/>
              </a:ext>
            </a:extLst>
          </p:cNvPr>
          <p:cNvSpPr txBox="1"/>
          <p:nvPr/>
        </p:nvSpPr>
        <p:spPr>
          <a:xfrm>
            <a:off x="6394919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4E185A-3C17-9EB7-7855-2F038CA74FF8}"/>
              </a:ext>
            </a:extLst>
          </p:cNvPr>
          <p:cNvSpPr txBox="1"/>
          <p:nvPr/>
        </p:nvSpPr>
        <p:spPr>
          <a:xfrm>
            <a:off x="6786421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473143F-66D9-7E3B-73FD-96A81BAFEBB2}"/>
              </a:ext>
            </a:extLst>
          </p:cNvPr>
          <p:cNvSpPr txBox="1"/>
          <p:nvPr/>
        </p:nvSpPr>
        <p:spPr>
          <a:xfrm>
            <a:off x="7059474" y="2320006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0</Words>
  <Application>Microsoft Office PowerPoint</Application>
  <PresentationFormat>와이드스크린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4</cp:revision>
  <dcterms:created xsi:type="dcterms:W3CDTF">2024-02-08T02:01:38Z</dcterms:created>
  <dcterms:modified xsi:type="dcterms:W3CDTF">2024-02-08T04:28:17Z</dcterms:modified>
</cp:coreProperties>
</file>